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4"/>
  </p:notesMasterIdLst>
  <p:sldIdLst>
    <p:sldId id="282" r:id="rId2"/>
    <p:sldId id="294" r:id="rId3"/>
  </p:sldIdLst>
  <p:sldSz cx="6492875" cy="6218238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437" userDrawn="1">
          <p15:clr>
            <a:srgbClr val="A4A3A4"/>
          </p15:clr>
        </p15:guide>
        <p15:guide id="3" orient="horz" pos="375" userDrawn="1">
          <p15:clr>
            <a:srgbClr val="A4A3A4"/>
          </p15:clr>
        </p15:guide>
        <p15:guide id="4" pos="1349" userDrawn="1">
          <p15:clr>
            <a:srgbClr val="A4A3A4"/>
          </p15:clr>
        </p15:guide>
        <p15:guide id="5" orient="horz" pos="203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udhary, Ritu" initials="CR" lastIdx="1" clrIdx="0">
    <p:extLst>
      <p:ext uri="{19B8F6BF-5375-455C-9EA6-DF929625EA0E}">
        <p15:presenceInfo xmlns:p15="http://schemas.microsoft.com/office/powerpoint/2012/main" userId="S::Ritu.Chaudhary@moffitt.org::e213b328-12f3-42f9-9afb-2fdf354946f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D0D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132" autoAdjust="0"/>
    <p:restoredTop sz="90099" autoAdjust="0"/>
  </p:normalViewPr>
  <p:slideViewPr>
    <p:cSldViewPr snapToGrid="0">
      <p:cViewPr varScale="1">
        <p:scale>
          <a:sx n="160" d="100"/>
          <a:sy n="160" d="100"/>
        </p:scale>
        <p:origin x="3736" y="84"/>
      </p:cViewPr>
      <p:guideLst>
        <p:guide pos="3437"/>
        <p:guide orient="horz" pos="375"/>
        <p:guide pos="1349"/>
        <p:guide orient="horz" pos="203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E3D79D2C-534C-49B8-BF89-98F21FED85F5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71663" y="1163638"/>
            <a:ext cx="32797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3FBF2B51-D0C1-4CC3-B696-54FB44FD7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484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1pPr>
    <a:lvl2pPr marL="22876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2pPr>
    <a:lvl3pPr marL="45752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3pPr>
    <a:lvl4pPr marL="68628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4pPr>
    <a:lvl5pPr marL="91504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5pPr>
    <a:lvl6pPr marL="114379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6pPr>
    <a:lvl7pPr marL="137255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7pPr>
    <a:lvl8pPr marL="160131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8pPr>
    <a:lvl9pPr marL="183007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BF2B51-D0C1-4CC3-B696-54FB44FD7B1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6273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017661"/>
            <a:ext cx="5518944" cy="2164868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3266015"/>
            <a:ext cx="4869656" cy="1501301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752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62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331064"/>
            <a:ext cx="1400026" cy="52696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331064"/>
            <a:ext cx="4118918" cy="52696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30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61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1550243"/>
            <a:ext cx="5600105" cy="2586614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4161327"/>
            <a:ext cx="5600105" cy="136023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/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75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75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530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408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331065"/>
            <a:ext cx="5600105" cy="12019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1524332"/>
            <a:ext cx="2746790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2271384"/>
            <a:ext cx="2746790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1524332"/>
            <a:ext cx="2760318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2271384"/>
            <a:ext cx="2760318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870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38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378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895313"/>
            <a:ext cx="3287018" cy="4418979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80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895313"/>
            <a:ext cx="3287018" cy="4418979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0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331065"/>
            <a:ext cx="5600105" cy="12019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1655318"/>
            <a:ext cx="5600105" cy="39454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5763387"/>
            <a:ext cx="2191345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252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7DF7B4A-40F2-4FF6-8F68-F13081F35D8E}"/>
              </a:ext>
            </a:extLst>
          </p:cNvPr>
          <p:cNvSpPr txBox="1"/>
          <p:nvPr/>
        </p:nvSpPr>
        <p:spPr>
          <a:xfrm>
            <a:off x="4950069" y="-17220"/>
            <a:ext cx="15815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D0CCF34-B65A-43BC-AF60-CAEB771EA3DE}"/>
              </a:ext>
            </a:extLst>
          </p:cNvPr>
          <p:cNvSpPr txBox="1"/>
          <p:nvPr/>
        </p:nvSpPr>
        <p:spPr>
          <a:xfrm>
            <a:off x="0" y="113198"/>
            <a:ext cx="6429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FA32F93-0AB5-4016-97C6-9E1F6D25F090}"/>
              </a:ext>
            </a:extLst>
          </p:cNvPr>
          <p:cNvSpPr txBox="1"/>
          <p:nvPr/>
        </p:nvSpPr>
        <p:spPr>
          <a:xfrm>
            <a:off x="-1" y="2344072"/>
            <a:ext cx="6429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3630E47-EB1D-4475-8E00-75E3509BCF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44" y="351847"/>
            <a:ext cx="6421943" cy="183553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41083B2-2115-420B-80E6-3D538BE65D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676" y="2489065"/>
            <a:ext cx="5072108" cy="2836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1594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551321D-1DC8-4F4C-AD28-708D065337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507" y="413668"/>
            <a:ext cx="4592597" cy="22797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56FCA8F-9651-4743-A548-2555D7F3B3E4}"/>
              </a:ext>
            </a:extLst>
          </p:cNvPr>
          <p:cNvSpPr txBox="1"/>
          <p:nvPr/>
        </p:nvSpPr>
        <p:spPr>
          <a:xfrm>
            <a:off x="0" y="171847"/>
            <a:ext cx="642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28966A5-38E2-4435-80D3-DA56445CA0D0}"/>
              </a:ext>
            </a:extLst>
          </p:cNvPr>
          <p:cNvSpPr txBox="1"/>
          <p:nvPr/>
        </p:nvSpPr>
        <p:spPr>
          <a:xfrm>
            <a:off x="4932485" y="363"/>
            <a:ext cx="15815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0B48568-7431-499D-BABA-A8B6EB72A10B}"/>
              </a:ext>
            </a:extLst>
          </p:cNvPr>
          <p:cNvSpPr txBox="1"/>
          <p:nvPr/>
        </p:nvSpPr>
        <p:spPr>
          <a:xfrm>
            <a:off x="105507" y="3024554"/>
            <a:ext cx="605790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1: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A, B) Heatmap of molecular subgroups in two different HNSCC datasets (A) TCGA and (B) CPTAC. RNA expression data was z-normalized, each row represents a single gene in the hypoxia-immune signature gene list, each column represents a patient sample. Samples were reordered according to its molecular subgroup: Immune (blue), Mixture (black) and Hypoxia (red). (C) Kaplan–Meier survival plots for overall survival stratified according to the hypoxia-immune signature for TCGA (n = 518) HNSCC patient cohorts. 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58917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714</TotalTime>
  <Words>114</Words>
  <Application>Microsoft Office PowerPoint</Application>
  <PresentationFormat>Custom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udhary, Ritu</dc:creator>
  <cp:lastModifiedBy>Chung, Christine H</cp:lastModifiedBy>
  <cp:revision>383</cp:revision>
  <cp:lastPrinted>2022-01-03T15:25:01Z</cp:lastPrinted>
  <dcterms:created xsi:type="dcterms:W3CDTF">2021-01-11T21:01:01Z</dcterms:created>
  <dcterms:modified xsi:type="dcterms:W3CDTF">2023-04-30T13:04:16Z</dcterms:modified>
</cp:coreProperties>
</file>